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451"/>
    <p:restoredTop sz="94721"/>
  </p:normalViewPr>
  <p:slideViewPr>
    <p:cSldViewPr snapToGrid="0">
      <p:cViewPr varScale="1">
        <p:scale>
          <a:sx n="140" d="100"/>
          <a:sy n="140" d="100"/>
        </p:scale>
        <p:origin x="640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81B2AE-9900-E85D-478A-18F1B66676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86BB7F3-C2C0-B036-1DB9-FDB09EF579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B04FD0-8DAC-68E4-3C9B-9CC4B61410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62000-439B-E125-BCFA-BAB5186E1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030E50-0F3E-8920-89F5-AD58CAAA45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2473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BE1029-F9CE-7911-EE38-76F5E4179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ADCEC4-3E2C-1BA6-B736-5446C4ACA2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D16857-B431-4144-FA90-53DCDEA123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7D4598-72BD-8469-E4AF-FAE14AA6F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E66C0-8210-D49D-A556-C84C8952EA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50043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F38610C-C22C-D092-13DA-D756D0F0A6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470CCB-9260-3A71-C757-F3CCF92F24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4FFD18-FD15-09B5-17A1-069CDDC45D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6801C7-7E2E-6A59-DDB4-10FF36E397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36A1DC-855D-D21B-AFEB-82D111B0C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6818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34391F8-54C4-1DD9-D7CD-FE38AAE7F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B49DFC-4D76-4571-2E86-343B9E773B2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DF0CDB-7BAA-4DF5-6CEA-B80985B6C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26E651-ECC2-063E-E8EF-D98BA1D9D8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06CEAA-5A5A-A515-29B6-2345CC778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032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6C6EA-8CEB-FAC2-83B3-56D9388994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9249A3-6E95-BCEB-93EB-92D29C7124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1A221B-B9EC-0C96-F409-EB572D2315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6AD0EB-AFF3-FF80-F23C-04A95A4F95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46AAB-E713-430A-1F90-4EBE754086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5245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68833B-5DE9-7090-52BA-59B3F1F677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F04AA6-4FA0-E4D9-8059-47628888FB4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EFDCE9-4EA9-6BB9-32C7-ED721E5E7B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96B22A4-F676-247A-0337-E1F5DF8C61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363A10-084E-794B-511E-33E9DED3E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9A1BDE8-3E4E-875E-2C7C-8E79B4A241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925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EC45F2-F43E-DAA2-633D-AD81CA45B2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5B9FB0-86F8-D9AB-A91E-7E1A7583EC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2D9F29-C612-EF92-AD78-926F4FE712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422E48-8A72-34C9-667F-71AF7D5C02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0B514E2-BECD-B5F5-7E3C-4A2B45D6BD2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3E446C3-FFE2-6563-85BB-AEC7B0180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D9E0D99-B64E-D175-ED52-CC988DFEE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52374C7-F215-E40D-D173-BD56D4C232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18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19715B-1F41-473A-C2B6-7D386BD1DB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AC94A4-479A-A15E-7FEC-C8C00B24F4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60C7F2C-D9CA-E790-2413-E0DCBB8D4B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F79D7E-9CD7-9898-5511-59787779C8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3552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1A27627-01C6-C771-94BA-55C22D69F4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D0D0B13-04D7-F629-5A41-E4E8A66CA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4F0C74B-84D4-5E6A-AA95-12BD80233F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7499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585BCA-3B0E-FE79-2C19-67B827345B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D4A7E7-30DF-5CB9-E298-D2A841AF2D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EB132C8-5118-25C6-1A90-1142F44AC9F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22BB80-8BA2-6AEC-5EF4-3687A461B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EE0F768-1821-AE4C-2E50-10A71FD51A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A01370-2A02-354E-414D-7D1A2A6858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6176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4B04C5-CC51-6A85-FC7D-B75E3349AE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892A7D3-FC21-74E5-9C32-83307571B7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F023B98-3FD2-A919-58FD-3A4BE2C5EC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0D2F77-916C-9BBD-C513-DA292A3C8B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20C0A9B-1260-96F4-93BC-8C2D9175C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3907D2-5E79-2344-BAB4-C30DE941E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03979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1F0AAA9-15A2-6AFF-2FF8-0B8CDA3B24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BE4138C-E380-CC6D-BCEE-4E8E094E00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A20415-B039-510C-A0CA-E04B2835707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0825EC-EF76-9C48-86FA-F48FD3EE3A75}" type="datetimeFigureOut">
              <a:rPr lang="en-US" smtClean="0"/>
              <a:t>9/6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4CB2F2-CE9A-7912-2163-B8C9105DF4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A8C179-AAA2-CF93-605C-BF8F4846C8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89C2C6-FA6B-0746-BC74-915F25EE0D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6918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05652B0-BBF1-F5E4-FD74-3A5DD949348B}"/>
              </a:ext>
            </a:extLst>
          </p:cNvPr>
          <p:cNvSpPr txBox="1"/>
          <p:nvPr/>
        </p:nvSpPr>
        <p:spPr>
          <a:xfrm>
            <a:off x="1470454" y="531341"/>
            <a:ext cx="14141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Illumina 40X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B46058B5-CD0B-AF2B-031D-3D1E53C8B71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4936399"/>
              </p:ext>
            </p:extLst>
          </p:nvPr>
        </p:nvGraphicFramePr>
        <p:xfrm>
          <a:off x="1882712" y="1253325"/>
          <a:ext cx="8852342" cy="4351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2023">
                  <a:extLst>
                    <a:ext uri="{9D8B030D-6E8A-4147-A177-3AD203B41FA5}">
                      <a16:colId xmlns:a16="http://schemas.microsoft.com/office/drawing/2014/main" val="522489885"/>
                    </a:ext>
                  </a:extLst>
                </a:gridCol>
                <a:gridCol w="953720">
                  <a:extLst>
                    <a:ext uri="{9D8B030D-6E8A-4147-A177-3AD203B41FA5}">
                      <a16:colId xmlns:a16="http://schemas.microsoft.com/office/drawing/2014/main" val="3016068405"/>
                    </a:ext>
                  </a:extLst>
                </a:gridCol>
                <a:gridCol w="662023">
                  <a:extLst>
                    <a:ext uri="{9D8B030D-6E8A-4147-A177-3AD203B41FA5}">
                      <a16:colId xmlns:a16="http://schemas.microsoft.com/office/drawing/2014/main" val="3860453941"/>
                    </a:ext>
                  </a:extLst>
                </a:gridCol>
                <a:gridCol w="722899">
                  <a:extLst>
                    <a:ext uri="{9D8B030D-6E8A-4147-A177-3AD203B41FA5}">
                      <a16:colId xmlns:a16="http://schemas.microsoft.com/office/drawing/2014/main" val="553538071"/>
                    </a:ext>
                  </a:extLst>
                </a:gridCol>
                <a:gridCol w="862406">
                  <a:extLst>
                    <a:ext uri="{9D8B030D-6E8A-4147-A177-3AD203B41FA5}">
                      <a16:colId xmlns:a16="http://schemas.microsoft.com/office/drawing/2014/main" val="3036511281"/>
                    </a:ext>
                  </a:extLst>
                </a:gridCol>
                <a:gridCol w="722899">
                  <a:extLst>
                    <a:ext uri="{9D8B030D-6E8A-4147-A177-3AD203B41FA5}">
                      <a16:colId xmlns:a16="http://schemas.microsoft.com/office/drawing/2014/main" val="4167892489"/>
                    </a:ext>
                  </a:extLst>
                </a:gridCol>
                <a:gridCol w="662023">
                  <a:extLst>
                    <a:ext uri="{9D8B030D-6E8A-4147-A177-3AD203B41FA5}">
                      <a16:colId xmlns:a16="http://schemas.microsoft.com/office/drawing/2014/main" val="700859206"/>
                    </a:ext>
                  </a:extLst>
                </a:gridCol>
                <a:gridCol w="1240343">
                  <a:extLst>
                    <a:ext uri="{9D8B030D-6E8A-4147-A177-3AD203B41FA5}">
                      <a16:colId xmlns:a16="http://schemas.microsoft.com/office/drawing/2014/main" val="1778967275"/>
                    </a:ext>
                  </a:extLst>
                </a:gridCol>
                <a:gridCol w="740654">
                  <a:extLst>
                    <a:ext uri="{9D8B030D-6E8A-4147-A177-3AD203B41FA5}">
                      <a16:colId xmlns:a16="http://schemas.microsoft.com/office/drawing/2014/main" val="3310252227"/>
                    </a:ext>
                  </a:extLst>
                </a:gridCol>
                <a:gridCol w="740654">
                  <a:extLst>
                    <a:ext uri="{9D8B030D-6E8A-4147-A177-3AD203B41FA5}">
                      <a16:colId xmlns:a16="http://schemas.microsoft.com/office/drawing/2014/main" val="453898664"/>
                    </a:ext>
                  </a:extLst>
                </a:gridCol>
                <a:gridCol w="882698">
                  <a:extLst>
                    <a:ext uri="{9D8B030D-6E8A-4147-A177-3AD203B41FA5}">
                      <a16:colId xmlns:a16="http://schemas.microsoft.com/office/drawing/2014/main" val="4176694016"/>
                    </a:ext>
                  </a:extLst>
                </a:gridCol>
              </a:tblGrid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na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gion size (bp)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tools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nder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render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52560799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nam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gion size (bp)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tools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tim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tim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tim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nder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render_time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me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me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mem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245001770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262183411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59978707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807775533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192239597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0.022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2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3960342133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361440842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9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633069578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4093989579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4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.0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1.8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4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3566812048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0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9.5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9.2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2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108862014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6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3.2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3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8.8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9.44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370799091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9.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42.8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6.5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86.0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09.0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182274558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4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.3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0.4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0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3944018885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1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9.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.8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3514508126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2.9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3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8.3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.2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4090495247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3.4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0.0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0.1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3.7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5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04.8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076896598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6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1.5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2.6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5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407685399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9.9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4.7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2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88484756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5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7.9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9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3.3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.0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818955149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4.2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3.1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1.72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1.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23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7.72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203578311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4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9.7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2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50846817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6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6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.1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2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611344015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8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6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3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5.0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659802820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2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7.4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.7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4.71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.8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972559700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1.1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1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1583055213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3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54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2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8.2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1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985909396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.1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9.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1.9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20.6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666898395"/>
                  </a:ext>
                </a:extLst>
              </a:tr>
              <a:tr h="145045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6.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55.3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6.6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44.9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5.898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6799" marR="6799" marT="6799" marB="0" anchor="b"/>
                </a:tc>
                <a:extLst>
                  <a:ext uri="{0D108BD9-81ED-4DB2-BD59-A6C34878D82A}">
                    <a16:rowId xmlns:a16="http://schemas.microsoft.com/office/drawing/2014/main" val="27217633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28760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2B0C1FF-F09E-6FB2-7608-0FED0A2B9ACD}"/>
              </a:ext>
            </a:extLst>
          </p:cNvPr>
          <p:cNvSpPr txBox="1"/>
          <p:nvPr/>
        </p:nvSpPr>
        <p:spPr>
          <a:xfrm>
            <a:off x="1545021" y="725214"/>
            <a:ext cx="1611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acBio HiFi 8X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54ADA9F-25C7-7AA6-A9F7-490CBCDAF1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301921"/>
              </p:ext>
            </p:extLst>
          </p:nvPr>
        </p:nvGraphicFramePr>
        <p:xfrm>
          <a:off x="1718755" y="1256224"/>
          <a:ext cx="8998014" cy="43513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72918">
                  <a:extLst>
                    <a:ext uri="{9D8B030D-6E8A-4147-A177-3AD203B41FA5}">
                      <a16:colId xmlns:a16="http://schemas.microsoft.com/office/drawing/2014/main" val="3151977162"/>
                    </a:ext>
                  </a:extLst>
                </a:gridCol>
                <a:gridCol w="969414">
                  <a:extLst>
                    <a:ext uri="{9D8B030D-6E8A-4147-A177-3AD203B41FA5}">
                      <a16:colId xmlns:a16="http://schemas.microsoft.com/office/drawing/2014/main" val="3631819571"/>
                    </a:ext>
                  </a:extLst>
                </a:gridCol>
                <a:gridCol w="672918">
                  <a:extLst>
                    <a:ext uri="{9D8B030D-6E8A-4147-A177-3AD203B41FA5}">
                      <a16:colId xmlns:a16="http://schemas.microsoft.com/office/drawing/2014/main" val="3760353988"/>
                    </a:ext>
                  </a:extLst>
                </a:gridCol>
                <a:gridCol w="734794">
                  <a:extLst>
                    <a:ext uri="{9D8B030D-6E8A-4147-A177-3AD203B41FA5}">
                      <a16:colId xmlns:a16="http://schemas.microsoft.com/office/drawing/2014/main" val="4228522060"/>
                    </a:ext>
                  </a:extLst>
                </a:gridCol>
                <a:gridCol w="876598">
                  <a:extLst>
                    <a:ext uri="{9D8B030D-6E8A-4147-A177-3AD203B41FA5}">
                      <a16:colId xmlns:a16="http://schemas.microsoft.com/office/drawing/2014/main" val="3029369886"/>
                    </a:ext>
                  </a:extLst>
                </a:gridCol>
                <a:gridCol w="734794">
                  <a:extLst>
                    <a:ext uri="{9D8B030D-6E8A-4147-A177-3AD203B41FA5}">
                      <a16:colId xmlns:a16="http://schemas.microsoft.com/office/drawing/2014/main" val="768766929"/>
                    </a:ext>
                  </a:extLst>
                </a:gridCol>
                <a:gridCol w="672918">
                  <a:extLst>
                    <a:ext uri="{9D8B030D-6E8A-4147-A177-3AD203B41FA5}">
                      <a16:colId xmlns:a16="http://schemas.microsoft.com/office/drawing/2014/main" val="1863069389"/>
                    </a:ext>
                  </a:extLst>
                </a:gridCol>
                <a:gridCol w="1260753">
                  <a:extLst>
                    <a:ext uri="{9D8B030D-6E8A-4147-A177-3AD203B41FA5}">
                      <a16:colId xmlns:a16="http://schemas.microsoft.com/office/drawing/2014/main" val="2832316811"/>
                    </a:ext>
                  </a:extLst>
                </a:gridCol>
                <a:gridCol w="752842">
                  <a:extLst>
                    <a:ext uri="{9D8B030D-6E8A-4147-A177-3AD203B41FA5}">
                      <a16:colId xmlns:a16="http://schemas.microsoft.com/office/drawing/2014/main" val="931744896"/>
                    </a:ext>
                  </a:extLst>
                </a:gridCol>
                <a:gridCol w="752842">
                  <a:extLst>
                    <a:ext uri="{9D8B030D-6E8A-4147-A177-3AD203B41FA5}">
                      <a16:colId xmlns:a16="http://schemas.microsoft.com/office/drawing/2014/main" val="1620976032"/>
                    </a:ext>
                  </a:extLst>
                </a:gridCol>
                <a:gridCol w="897223">
                  <a:extLst>
                    <a:ext uri="{9D8B030D-6E8A-4147-A177-3AD203B41FA5}">
                      <a16:colId xmlns:a16="http://schemas.microsoft.com/office/drawing/2014/main" val="516883883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na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gion size (bp)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tools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nder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render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24105174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86673368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05359256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36233793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27130729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4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77233619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50169656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1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1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1643418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62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6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75085518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1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6.2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6.4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9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330629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8.9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48.1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5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53477287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0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6.5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9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41.3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2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82436824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8.2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2.3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36.7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6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3.8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27745546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1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6.5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0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4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8594837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4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9.2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2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6.8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1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69867571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0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6.7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9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42.4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1.7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8551961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8.4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4.2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.3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41.31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8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7.3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54250749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7.5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8.7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2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81353196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7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9.3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17.8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7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80534244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8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0.64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3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6.6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9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37259086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7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2.6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1.2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51.0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1.6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76484397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2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.9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7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77603833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67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7.04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9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037775965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7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0.5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9.86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3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16669399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52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1.42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7.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8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.8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93525276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0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10.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8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59941728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7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5.6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6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91.5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8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61501082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.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9.9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.6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963.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8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08175251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72.1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535.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71.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829.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3.313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92447302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51779497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EC157D9-2009-6382-0CC5-111C292A18A8}"/>
              </a:ext>
            </a:extLst>
          </p:cNvPr>
          <p:cNvSpPr txBox="1"/>
          <p:nvPr/>
        </p:nvSpPr>
        <p:spPr>
          <a:xfrm>
            <a:off x="1397876" y="672662"/>
            <a:ext cx="1603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T Kit14 45X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0B405559-A02D-B658-D6E3-2A5F3AD1642F}"/>
              </a:ext>
            </a:extLst>
          </p:cNvPr>
          <p:cNvGraphicFramePr>
            <a:graphicFrameLocks noGrp="1"/>
          </p:cNvGraphicFramePr>
          <p:nvPr/>
        </p:nvGraphicFramePr>
        <p:xfrm>
          <a:off x="1358900" y="1254125"/>
          <a:ext cx="9475034" cy="4351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8591">
                  <a:extLst>
                    <a:ext uri="{9D8B030D-6E8A-4147-A177-3AD203B41FA5}">
                      <a16:colId xmlns:a16="http://schemas.microsoft.com/office/drawing/2014/main" val="2899647067"/>
                    </a:ext>
                  </a:extLst>
                </a:gridCol>
                <a:gridCol w="1020807">
                  <a:extLst>
                    <a:ext uri="{9D8B030D-6E8A-4147-A177-3AD203B41FA5}">
                      <a16:colId xmlns:a16="http://schemas.microsoft.com/office/drawing/2014/main" val="1002261462"/>
                    </a:ext>
                  </a:extLst>
                </a:gridCol>
                <a:gridCol w="708591">
                  <a:extLst>
                    <a:ext uri="{9D8B030D-6E8A-4147-A177-3AD203B41FA5}">
                      <a16:colId xmlns:a16="http://schemas.microsoft.com/office/drawing/2014/main" val="434655070"/>
                    </a:ext>
                  </a:extLst>
                </a:gridCol>
                <a:gridCol w="773749">
                  <a:extLst>
                    <a:ext uri="{9D8B030D-6E8A-4147-A177-3AD203B41FA5}">
                      <a16:colId xmlns:a16="http://schemas.microsoft.com/office/drawing/2014/main" val="2624958781"/>
                    </a:ext>
                  </a:extLst>
                </a:gridCol>
                <a:gridCol w="923069">
                  <a:extLst>
                    <a:ext uri="{9D8B030D-6E8A-4147-A177-3AD203B41FA5}">
                      <a16:colId xmlns:a16="http://schemas.microsoft.com/office/drawing/2014/main" val="585909031"/>
                    </a:ext>
                  </a:extLst>
                </a:gridCol>
                <a:gridCol w="773749">
                  <a:extLst>
                    <a:ext uri="{9D8B030D-6E8A-4147-A177-3AD203B41FA5}">
                      <a16:colId xmlns:a16="http://schemas.microsoft.com/office/drawing/2014/main" val="2070119529"/>
                    </a:ext>
                  </a:extLst>
                </a:gridCol>
                <a:gridCol w="708591">
                  <a:extLst>
                    <a:ext uri="{9D8B030D-6E8A-4147-A177-3AD203B41FA5}">
                      <a16:colId xmlns:a16="http://schemas.microsoft.com/office/drawing/2014/main" val="3946091141"/>
                    </a:ext>
                  </a:extLst>
                </a:gridCol>
                <a:gridCol w="1327591">
                  <a:extLst>
                    <a:ext uri="{9D8B030D-6E8A-4147-A177-3AD203B41FA5}">
                      <a16:colId xmlns:a16="http://schemas.microsoft.com/office/drawing/2014/main" val="978188285"/>
                    </a:ext>
                  </a:extLst>
                </a:gridCol>
                <a:gridCol w="792754">
                  <a:extLst>
                    <a:ext uri="{9D8B030D-6E8A-4147-A177-3AD203B41FA5}">
                      <a16:colId xmlns:a16="http://schemas.microsoft.com/office/drawing/2014/main" val="2913988113"/>
                    </a:ext>
                  </a:extLst>
                </a:gridCol>
                <a:gridCol w="792754">
                  <a:extLst>
                    <a:ext uri="{9D8B030D-6E8A-4147-A177-3AD203B41FA5}">
                      <a16:colId xmlns:a16="http://schemas.microsoft.com/office/drawing/2014/main" val="1200807905"/>
                    </a:ext>
                  </a:extLst>
                </a:gridCol>
                <a:gridCol w="944788">
                  <a:extLst>
                    <a:ext uri="{9D8B030D-6E8A-4147-A177-3AD203B41FA5}">
                      <a16:colId xmlns:a16="http://schemas.microsoft.com/office/drawing/2014/main" val="1851641563"/>
                    </a:ext>
                  </a:extLst>
                </a:gridCol>
              </a:tblGrid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a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gion size (bp)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tools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otal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lative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tart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nder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lative_render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otal_mem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tart_mem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lative_mem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21497904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10439825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75440845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19013692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8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7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9015596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9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36811062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9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5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6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0048997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9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8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23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36652980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4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0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99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84753442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0.8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0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7.6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5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19004392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1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5.0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1.9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1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.99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417822983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.1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6.07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9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16.07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5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9.48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601050683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9.27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8.9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6.06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65.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.53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4.84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117588556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1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4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66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06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15763194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18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5.33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7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4.19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47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.5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97168204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.2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6.1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9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16.23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3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.6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21894648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7.2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3.5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2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4.00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57.6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3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2.8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03106092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02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7.3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6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6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9.25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7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9.68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52239791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30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7.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6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4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2.66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5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7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9.9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30859328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41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3.8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6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7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7.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2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7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3.6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29635104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3.3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7.1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6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0.66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9.87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25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7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2.1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38552848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7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13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8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1.8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61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841507362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71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3.47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67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428160558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8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.49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23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8.7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7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96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54630185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.5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8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1.96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2.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5.51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64635301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256886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0A9CDE-5CDB-6BF6-340F-9C2892D06837}"/>
              </a:ext>
            </a:extLst>
          </p:cNvPr>
          <p:cNvSpPr txBox="1"/>
          <p:nvPr/>
        </p:nvSpPr>
        <p:spPr>
          <a:xfrm>
            <a:off x="1397876" y="672662"/>
            <a:ext cx="23855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T Kit14 45X + mods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90C6C107-B6FB-2313-EFE4-235DB250654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8358455"/>
              </p:ext>
            </p:extLst>
          </p:nvPr>
        </p:nvGraphicFramePr>
        <p:xfrm>
          <a:off x="876300" y="1224190"/>
          <a:ext cx="10286998" cy="362648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143">
                  <a:extLst>
                    <a:ext uri="{9D8B030D-6E8A-4147-A177-3AD203B41FA5}">
                      <a16:colId xmlns:a16="http://schemas.microsoft.com/office/drawing/2014/main" val="2986015336"/>
                    </a:ext>
                  </a:extLst>
                </a:gridCol>
                <a:gridCol w="1191593">
                  <a:extLst>
                    <a:ext uri="{9D8B030D-6E8A-4147-A177-3AD203B41FA5}">
                      <a16:colId xmlns:a16="http://schemas.microsoft.com/office/drawing/2014/main" val="4152544414"/>
                    </a:ext>
                  </a:extLst>
                </a:gridCol>
                <a:gridCol w="827143">
                  <a:extLst>
                    <a:ext uri="{9D8B030D-6E8A-4147-A177-3AD203B41FA5}">
                      <a16:colId xmlns:a16="http://schemas.microsoft.com/office/drawing/2014/main" val="848921368"/>
                    </a:ext>
                  </a:extLst>
                </a:gridCol>
                <a:gridCol w="903202">
                  <a:extLst>
                    <a:ext uri="{9D8B030D-6E8A-4147-A177-3AD203B41FA5}">
                      <a16:colId xmlns:a16="http://schemas.microsoft.com/office/drawing/2014/main" val="947703092"/>
                    </a:ext>
                  </a:extLst>
                </a:gridCol>
                <a:gridCol w="636995">
                  <a:extLst>
                    <a:ext uri="{9D8B030D-6E8A-4147-A177-3AD203B41FA5}">
                      <a16:colId xmlns:a16="http://schemas.microsoft.com/office/drawing/2014/main" val="2310071342"/>
                    </a:ext>
                  </a:extLst>
                </a:gridCol>
                <a:gridCol w="570444">
                  <a:extLst>
                    <a:ext uri="{9D8B030D-6E8A-4147-A177-3AD203B41FA5}">
                      <a16:colId xmlns:a16="http://schemas.microsoft.com/office/drawing/2014/main" val="4123256034"/>
                    </a:ext>
                  </a:extLst>
                </a:gridCol>
                <a:gridCol w="827143">
                  <a:extLst>
                    <a:ext uri="{9D8B030D-6E8A-4147-A177-3AD203B41FA5}">
                      <a16:colId xmlns:a16="http://schemas.microsoft.com/office/drawing/2014/main" val="1425908915"/>
                    </a:ext>
                  </a:extLst>
                </a:gridCol>
                <a:gridCol w="1549705">
                  <a:extLst>
                    <a:ext uri="{9D8B030D-6E8A-4147-A177-3AD203B41FA5}">
                      <a16:colId xmlns:a16="http://schemas.microsoft.com/office/drawing/2014/main" val="2219313635"/>
                    </a:ext>
                  </a:extLst>
                </a:gridCol>
                <a:gridCol w="925386">
                  <a:extLst>
                    <a:ext uri="{9D8B030D-6E8A-4147-A177-3AD203B41FA5}">
                      <a16:colId xmlns:a16="http://schemas.microsoft.com/office/drawing/2014/main" val="2689002468"/>
                    </a:ext>
                  </a:extLst>
                </a:gridCol>
                <a:gridCol w="925386">
                  <a:extLst>
                    <a:ext uri="{9D8B030D-6E8A-4147-A177-3AD203B41FA5}">
                      <a16:colId xmlns:a16="http://schemas.microsoft.com/office/drawing/2014/main" val="3358895776"/>
                    </a:ext>
                  </a:extLst>
                </a:gridCol>
                <a:gridCol w="1102858">
                  <a:extLst>
                    <a:ext uri="{9D8B030D-6E8A-4147-A177-3AD203B41FA5}">
                      <a16:colId xmlns:a16="http://schemas.microsoft.com/office/drawing/2014/main" val="3050623618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na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gion size (bp)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amtools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total_ti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lative_ti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tart_ti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nder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lative_render_ti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total_mem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tart_mem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lative_mem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892170364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184575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2894230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6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9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8643195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3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4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30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2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75184428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1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99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9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04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8827901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99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2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9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9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06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2167735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5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7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9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7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80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1539281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70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8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6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8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9921897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93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3.95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49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6.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42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.91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72542532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8.10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3.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.66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.10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57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.6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79723368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6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0.3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3.09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.88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77.2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86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9.38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07944008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3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6.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60.7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2.71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4.78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.79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7.33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90238701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2.70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3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3.0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35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.0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25635384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4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.16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7.92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.7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16.8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5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.67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44487440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05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9.36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48.1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.92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6.45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.14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2.35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5488096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igv -t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11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5.7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35.40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3.4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52.2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170.72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6.447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0.2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 dirty="0">
                          <a:effectLst/>
                        </a:rPr>
                        <a:t>52.67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6319538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06352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B97368F-E811-BDB4-9BD0-F4C03A0F44A1}"/>
              </a:ext>
            </a:extLst>
          </p:cNvPr>
          <p:cNvSpPr txBox="1"/>
          <p:nvPr/>
        </p:nvSpPr>
        <p:spPr>
          <a:xfrm>
            <a:off x="1198179" y="641131"/>
            <a:ext cx="1603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T Kit14 90X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6904606-BDB9-E0DB-252C-23B98CD03306}"/>
              </a:ext>
            </a:extLst>
          </p:cNvPr>
          <p:cNvGraphicFramePr>
            <a:graphicFrameLocks noGrp="1"/>
          </p:cNvGraphicFramePr>
          <p:nvPr/>
        </p:nvGraphicFramePr>
        <p:xfrm>
          <a:off x="1358900" y="1254125"/>
          <a:ext cx="9475034" cy="43513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8591">
                  <a:extLst>
                    <a:ext uri="{9D8B030D-6E8A-4147-A177-3AD203B41FA5}">
                      <a16:colId xmlns:a16="http://schemas.microsoft.com/office/drawing/2014/main" val="730371070"/>
                    </a:ext>
                  </a:extLst>
                </a:gridCol>
                <a:gridCol w="1020807">
                  <a:extLst>
                    <a:ext uri="{9D8B030D-6E8A-4147-A177-3AD203B41FA5}">
                      <a16:colId xmlns:a16="http://schemas.microsoft.com/office/drawing/2014/main" val="2679065238"/>
                    </a:ext>
                  </a:extLst>
                </a:gridCol>
                <a:gridCol w="708591">
                  <a:extLst>
                    <a:ext uri="{9D8B030D-6E8A-4147-A177-3AD203B41FA5}">
                      <a16:colId xmlns:a16="http://schemas.microsoft.com/office/drawing/2014/main" val="2838320136"/>
                    </a:ext>
                  </a:extLst>
                </a:gridCol>
                <a:gridCol w="773749">
                  <a:extLst>
                    <a:ext uri="{9D8B030D-6E8A-4147-A177-3AD203B41FA5}">
                      <a16:colId xmlns:a16="http://schemas.microsoft.com/office/drawing/2014/main" val="1852539563"/>
                    </a:ext>
                  </a:extLst>
                </a:gridCol>
                <a:gridCol w="923069">
                  <a:extLst>
                    <a:ext uri="{9D8B030D-6E8A-4147-A177-3AD203B41FA5}">
                      <a16:colId xmlns:a16="http://schemas.microsoft.com/office/drawing/2014/main" val="644359634"/>
                    </a:ext>
                  </a:extLst>
                </a:gridCol>
                <a:gridCol w="773749">
                  <a:extLst>
                    <a:ext uri="{9D8B030D-6E8A-4147-A177-3AD203B41FA5}">
                      <a16:colId xmlns:a16="http://schemas.microsoft.com/office/drawing/2014/main" val="315764962"/>
                    </a:ext>
                  </a:extLst>
                </a:gridCol>
                <a:gridCol w="708591">
                  <a:extLst>
                    <a:ext uri="{9D8B030D-6E8A-4147-A177-3AD203B41FA5}">
                      <a16:colId xmlns:a16="http://schemas.microsoft.com/office/drawing/2014/main" val="3795252203"/>
                    </a:ext>
                  </a:extLst>
                </a:gridCol>
                <a:gridCol w="1327591">
                  <a:extLst>
                    <a:ext uri="{9D8B030D-6E8A-4147-A177-3AD203B41FA5}">
                      <a16:colId xmlns:a16="http://schemas.microsoft.com/office/drawing/2014/main" val="832077943"/>
                    </a:ext>
                  </a:extLst>
                </a:gridCol>
                <a:gridCol w="792754">
                  <a:extLst>
                    <a:ext uri="{9D8B030D-6E8A-4147-A177-3AD203B41FA5}">
                      <a16:colId xmlns:a16="http://schemas.microsoft.com/office/drawing/2014/main" val="2433933346"/>
                    </a:ext>
                  </a:extLst>
                </a:gridCol>
                <a:gridCol w="792754">
                  <a:extLst>
                    <a:ext uri="{9D8B030D-6E8A-4147-A177-3AD203B41FA5}">
                      <a16:colId xmlns:a16="http://schemas.microsoft.com/office/drawing/2014/main" val="4105953105"/>
                    </a:ext>
                  </a:extLst>
                </a:gridCol>
                <a:gridCol w="944788">
                  <a:extLst>
                    <a:ext uri="{9D8B030D-6E8A-4147-A177-3AD203B41FA5}">
                      <a16:colId xmlns:a16="http://schemas.microsoft.com/office/drawing/2014/main" val="1025510243"/>
                    </a:ext>
                  </a:extLst>
                </a:gridCol>
              </a:tblGrid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na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gion size (bp)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tools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otal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lative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tart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nder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lative_render_time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total_mem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tart_mem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relative_mem</a:t>
                      </a:r>
                      <a:endParaRPr lang="en-GB" sz="10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536831749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79139383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1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27699757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7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80556146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0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47714030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8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0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7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6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564005036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2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8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1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9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5940434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6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4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39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02270421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gw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7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46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0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5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18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01480599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77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40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6.87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47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95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817098329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5.91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7.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6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.92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36297294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.16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8.2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7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0.6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1.1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49604302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77.5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6.28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74.08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46.36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.35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75.59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5626291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4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74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2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29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4.19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4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60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165320325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57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5.92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1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7.3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61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4050598444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6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.20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8.44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7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1.08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64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6.52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83278325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igv -t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7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9.87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13.79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6.4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31.21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.63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78.1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413467443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.45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9.67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7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5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77.1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0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.5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089475457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.1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2.52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7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34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9.1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1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.56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534033401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9.18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2.6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7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39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95.81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4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4.62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4128324459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jb2expor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5.14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06.09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79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2.34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23.1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6.13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9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55.56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422836962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82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7.07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5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6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9.35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55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856392936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5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022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8.0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5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36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8.73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5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604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2104318610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09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793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6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5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.13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1.9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87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1.87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582023028"/>
                  </a:ext>
                </a:extLst>
              </a:tr>
              <a:tr h="174054">
                <a:tc>
                  <a:txBody>
                    <a:bodyPr/>
                    <a:lstStyle/>
                    <a:p>
                      <a:pPr algn="l" fontAlgn="b"/>
                      <a:r>
                        <a:rPr lang="en-GB" sz="1000" u="none" strike="noStrike">
                          <a:effectLst/>
                        </a:rPr>
                        <a:t>samplot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000000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3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1.66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35.29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658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21.01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41.509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56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>
                          <a:effectLst/>
                        </a:rPr>
                        <a:t>0.145</a:t>
                      </a:r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000" u="none" strike="noStrike" dirty="0">
                          <a:effectLst/>
                        </a:rPr>
                        <a:t>5.11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8159" marR="8159" marT="8159" marB="0" anchor="b"/>
                </a:tc>
                <a:extLst>
                  <a:ext uri="{0D108BD9-81ED-4DB2-BD59-A6C34878D82A}">
                    <a16:rowId xmlns:a16="http://schemas.microsoft.com/office/drawing/2014/main" val="18506296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634541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9AEACA3-41C7-1ED6-E6FC-DAB841A172E7}"/>
              </a:ext>
            </a:extLst>
          </p:cNvPr>
          <p:cNvSpPr txBox="1"/>
          <p:nvPr/>
        </p:nvSpPr>
        <p:spPr>
          <a:xfrm>
            <a:off x="1145628" y="819807"/>
            <a:ext cx="1925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NT R9.4.1 12.5X</a:t>
            </a:r>
          </a:p>
        </p:txBody>
      </p:sp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D2936E7-2B49-E32C-0881-61BCEF110B0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16646148"/>
              </p:ext>
            </p:extLst>
          </p:nvPr>
        </p:nvGraphicFramePr>
        <p:xfrm>
          <a:off x="1636459" y="1365504"/>
          <a:ext cx="9254044" cy="4351334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2065">
                  <a:extLst>
                    <a:ext uri="{9D8B030D-6E8A-4147-A177-3AD203B41FA5}">
                      <a16:colId xmlns:a16="http://schemas.microsoft.com/office/drawing/2014/main" val="2220920330"/>
                    </a:ext>
                  </a:extLst>
                </a:gridCol>
                <a:gridCol w="996998">
                  <a:extLst>
                    <a:ext uri="{9D8B030D-6E8A-4147-A177-3AD203B41FA5}">
                      <a16:colId xmlns:a16="http://schemas.microsoft.com/office/drawing/2014/main" val="3699255466"/>
                    </a:ext>
                  </a:extLst>
                </a:gridCol>
                <a:gridCol w="692065">
                  <a:extLst>
                    <a:ext uri="{9D8B030D-6E8A-4147-A177-3AD203B41FA5}">
                      <a16:colId xmlns:a16="http://schemas.microsoft.com/office/drawing/2014/main" val="2363338227"/>
                    </a:ext>
                  </a:extLst>
                </a:gridCol>
                <a:gridCol w="755702">
                  <a:extLst>
                    <a:ext uri="{9D8B030D-6E8A-4147-A177-3AD203B41FA5}">
                      <a16:colId xmlns:a16="http://schemas.microsoft.com/office/drawing/2014/main" val="4033528461"/>
                    </a:ext>
                  </a:extLst>
                </a:gridCol>
                <a:gridCol w="901541">
                  <a:extLst>
                    <a:ext uri="{9D8B030D-6E8A-4147-A177-3AD203B41FA5}">
                      <a16:colId xmlns:a16="http://schemas.microsoft.com/office/drawing/2014/main" val="3729960665"/>
                    </a:ext>
                  </a:extLst>
                </a:gridCol>
                <a:gridCol w="755702">
                  <a:extLst>
                    <a:ext uri="{9D8B030D-6E8A-4147-A177-3AD203B41FA5}">
                      <a16:colId xmlns:a16="http://schemas.microsoft.com/office/drawing/2014/main" val="2474619584"/>
                    </a:ext>
                  </a:extLst>
                </a:gridCol>
                <a:gridCol w="692065">
                  <a:extLst>
                    <a:ext uri="{9D8B030D-6E8A-4147-A177-3AD203B41FA5}">
                      <a16:colId xmlns:a16="http://schemas.microsoft.com/office/drawing/2014/main" val="4184110387"/>
                    </a:ext>
                  </a:extLst>
                </a:gridCol>
                <a:gridCol w="1296627">
                  <a:extLst>
                    <a:ext uri="{9D8B030D-6E8A-4147-A177-3AD203B41FA5}">
                      <a16:colId xmlns:a16="http://schemas.microsoft.com/office/drawing/2014/main" val="2060005701"/>
                    </a:ext>
                  </a:extLst>
                </a:gridCol>
                <a:gridCol w="774263">
                  <a:extLst>
                    <a:ext uri="{9D8B030D-6E8A-4147-A177-3AD203B41FA5}">
                      <a16:colId xmlns:a16="http://schemas.microsoft.com/office/drawing/2014/main" val="996357831"/>
                    </a:ext>
                  </a:extLst>
                </a:gridCol>
                <a:gridCol w="774263">
                  <a:extLst>
                    <a:ext uri="{9D8B030D-6E8A-4147-A177-3AD203B41FA5}">
                      <a16:colId xmlns:a16="http://schemas.microsoft.com/office/drawing/2014/main" val="3496843218"/>
                    </a:ext>
                  </a:extLst>
                </a:gridCol>
                <a:gridCol w="922753">
                  <a:extLst>
                    <a:ext uri="{9D8B030D-6E8A-4147-A177-3AD203B41FA5}">
                      <a16:colId xmlns:a16="http://schemas.microsoft.com/office/drawing/2014/main" val="3943758697"/>
                    </a:ext>
                  </a:extLst>
                </a:gridCol>
              </a:tblGrid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na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gion size (bp)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tools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nder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render_time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total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tart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relative_mem</a:t>
                      </a:r>
                      <a:endParaRPr lang="en-GB" sz="9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16139691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2000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37192945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14402946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03188504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9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85965780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7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44440506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1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5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25527008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65368444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w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8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8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7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1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13721413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6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6.7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6.9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4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7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67981644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2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.71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9.7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8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65766106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9.2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0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5.66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.57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45301861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1.6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64.4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8.2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56.3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8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5.1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53422478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62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6.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8.6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0.314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2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39488328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2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.56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83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8.6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8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3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56484058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3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8.7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98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4.3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6.0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515766228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igv -t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5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0.5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58.6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3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7.1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45.61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6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5.7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295531314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8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8.77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6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8.4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9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2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18070240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06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9.5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6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3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8.1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8.8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74464044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5.1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6.46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6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52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7.78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94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4.79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52808489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jb2expor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7.66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41.5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66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4.99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36.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.70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2.9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41191789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6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89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.28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1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125361059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74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20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2.5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17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78394682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.3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9.1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7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13.90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7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2115143906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samplot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42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8.00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85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4.78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53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1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7.1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848447563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2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63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.45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40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6.07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392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4247060931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92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7.84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.69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60.66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0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3338437480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0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4.4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41.645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4.176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646.969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5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.45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862660867"/>
                  </a:ext>
                </a:extLst>
              </a:tr>
              <a:tr h="150046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u="none" strike="noStrike">
                          <a:effectLst/>
                        </a:rPr>
                        <a:t>genomeview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00000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2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1.23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2053.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31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401.007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3790.13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258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>
                          <a:effectLst/>
                        </a:rPr>
                        <a:t>0.14</a:t>
                      </a:r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900" u="none" strike="noStrike" dirty="0">
                          <a:effectLst/>
                        </a:rPr>
                        <a:t>3.449</a:t>
                      </a:r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7033" marR="7033" marT="7033" marB="0" anchor="b"/>
                </a:tc>
                <a:extLst>
                  <a:ext uri="{0D108BD9-81ED-4DB2-BD59-A6C34878D82A}">
                    <a16:rowId xmlns:a16="http://schemas.microsoft.com/office/drawing/2014/main" val="134286357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39836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F386CEC-0970-410F-BF26-B0D9B6BA4A6B}"/>
              </a:ext>
            </a:extLst>
          </p:cNvPr>
          <p:cNvSpPr txBox="1"/>
          <p:nvPr/>
        </p:nvSpPr>
        <p:spPr>
          <a:xfrm>
            <a:off x="1965434" y="903890"/>
            <a:ext cx="2051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Pixel6 Illumina 40X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B5467136-8B61-05FE-44D1-C38227062D5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27394230"/>
              </p:ext>
            </p:extLst>
          </p:nvPr>
        </p:nvGraphicFramePr>
        <p:xfrm>
          <a:off x="2118178" y="1676400"/>
          <a:ext cx="4711700" cy="18288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27560">
                  <a:extLst>
                    <a:ext uri="{9D8B030D-6E8A-4147-A177-3AD203B41FA5}">
                      <a16:colId xmlns:a16="http://schemas.microsoft.com/office/drawing/2014/main" val="2416307508"/>
                    </a:ext>
                  </a:extLst>
                </a:gridCol>
                <a:gridCol w="1217559">
                  <a:extLst>
                    <a:ext uri="{9D8B030D-6E8A-4147-A177-3AD203B41FA5}">
                      <a16:colId xmlns:a16="http://schemas.microsoft.com/office/drawing/2014/main" val="2533002576"/>
                    </a:ext>
                  </a:extLst>
                </a:gridCol>
                <a:gridCol w="913169">
                  <a:extLst>
                    <a:ext uri="{9D8B030D-6E8A-4147-A177-3AD203B41FA5}">
                      <a16:colId xmlns:a16="http://schemas.microsoft.com/office/drawing/2014/main" val="3219168017"/>
                    </a:ext>
                  </a:extLst>
                </a:gridCol>
                <a:gridCol w="925852">
                  <a:extLst>
                    <a:ext uri="{9D8B030D-6E8A-4147-A177-3AD203B41FA5}">
                      <a16:colId xmlns:a16="http://schemas.microsoft.com/office/drawing/2014/main" val="3199356314"/>
                    </a:ext>
                  </a:extLst>
                </a:gridCol>
                <a:gridCol w="827560">
                  <a:extLst>
                    <a:ext uri="{9D8B030D-6E8A-4147-A177-3AD203B41FA5}">
                      <a16:colId xmlns:a16="http://schemas.microsoft.com/office/drawing/2014/main" val="2928861157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na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gion size (bp)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total_ti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start_time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render</a:t>
                      </a:r>
                      <a:endParaRPr lang="en-GB" sz="1200" b="1" i="0" u="none" strike="noStrike">
                        <a:solidFill>
                          <a:srgbClr val="FFFFFF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3820705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64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5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10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0320622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73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5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19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4470181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.036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5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495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368460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.69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54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.15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328232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59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4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10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613846731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711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4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222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24084708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993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4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504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21020265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l" fontAlgn="b"/>
                      <a:r>
                        <a:rPr lang="en-GB" sz="1200" u="none" strike="noStrike">
                          <a:effectLst/>
                        </a:rPr>
                        <a:t>gw -t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1200" u="none" strike="noStrike">
                          <a:effectLst/>
                        </a:rPr>
                        <a:t>2000000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1.348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>
                          <a:effectLst/>
                        </a:rPr>
                        <a:t>0.489</a:t>
                      </a:r>
                      <a:endParaRPr lang="en-GB" sz="12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</a:rPr>
                        <a:t>0.859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282226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50263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2024</Words>
  <Application>Microsoft Macintosh PowerPoint</Application>
  <PresentationFormat>Widescreen</PresentationFormat>
  <Paragraphs>1757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ptos Narrow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ez Cleal</dc:creator>
  <cp:lastModifiedBy>Kez Cleal</cp:lastModifiedBy>
  <cp:revision>5</cp:revision>
  <dcterms:created xsi:type="dcterms:W3CDTF">2024-07-26T11:04:14Z</dcterms:created>
  <dcterms:modified xsi:type="dcterms:W3CDTF">2024-09-06T15:30:19Z</dcterms:modified>
</cp:coreProperties>
</file>